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7051675" cy="93567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870DD-439F-4815-A5A6-89809A8F3A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CF5AB-1B2F-470F-9450-FE419E6640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0D2ED-DE9E-451D-A04D-2CF813F619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944590-B5F6-432B-BB5E-6F0A51AAC7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9466DC-50CC-404A-A6AD-7D9D19A15C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28AD7E-F342-4407-9483-87EAAD2A29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D6805-21FD-480E-93F4-724AB31C16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20FBFA-0C92-42BC-ACDB-DEF054B661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B56E8B-340C-4FA2-A171-808DE0EDCB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146006-070D-47AE-99A1-17A24E21F9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9661D-F76E-4784-A143-3C6EF27A32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F6590C-4D2E-4481-92E5-B1A127BF6D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195E9B-07C1-474F-93F0-E2578D4CE04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2"/>
          <p:cNvGrpSpPr/>
          <p:nvPr/>
        </p:nvGrpSpPr>
        <p:grpSpPr>
          <a:xfrm>
            <a:off x="1454040" y="295200"/>
            <a:ext cx="6775560" cy="5953320"/>
            <a:chOff x="1454040" y="295200"/>
            <a:chExt cx="6775560" cy="5953320"/>
          </a:xfrm>
        </p:grpSpPr>
        <p:grpSp>
          <p:nvGrpSpPr>
            <p:cNvPr id="42" name="Group 5"/>
            <p:cNvGrpSpPr/>
            <p:nvPr/>
          </p:nvGrpSpPr>
          <p:grpSpPr>
            <a:xfrm>
              <a:off x="1454040" y="295200"/>
              <a:ext cx="6775560" cy="5953320"/>
              <a:chOff x="1454040" y="295200"/>
              <a:chExt cx="6775560" cy="5953320"/>
            </a:xfrm>
          </p:grpSpPr>
          <p:pic>
            <p:nvPicPr>
              <p:cNvPr id="43" name="Picture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454040" y="295200"/>
                <a:ext cx="3125520" cy="2700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Picture 2" descr=""/>
              <p:cNvPicPr/>
              <p:nvPr/>
            </p:nvPicPr>
            <p:blipFill>
              <a:blip r:embed="rId2"/>
              <a:stretch/>
            </p:blipFill>
            <p:spPr>
              <a:xfrm>
                <a:off x="5244480" y="295200"/>
                <a:ext cx="2944440" cy="2700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3" descr=""/>
              <p:cNvPicPr/>
              <p:nvPr/>
            </p:nvPicPr>
            <p:blipFill>
              <a:blip r:embed="rId3"/>
              <a:stretch/>
            </p:blipFill>
            <p:spPr>
              <a:xfrm>
                <a:off x="1454040" y="3431160"/>
                <a:ext cx="3071880" cy="2817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4" descr=""/>
              <p:cNvPicPr/>
              <p:nvPr/>
            </p:nvPicPr>
            <p:blipFill>
              <a:blip r:embed="rId4"/>
              <a:stretch/>
            </p:blipFill>
            <p:spPr>
              <a:xfrm>
                <a:off x="5246280" y="3487680"/>
                <a:ext cx="2983320" cy="2736000"/>
              </a:xfrm>
              <a:prstGeom prst="rect">
                <a:avLst/>
              </a:prstGeom>
              <a:ln w="0">
                <a:noFill/>
              </a:ln>
            </p:spPr>
          </p:pic>
        </p:grpSp>
        <p:cxnSp>
          <p:nvCxnSpPr>
            <p:cNvPr id="47" name="Straight Arrow Connector 2"/>
            <p:cNvCxnSpPr/>
            <p:nvPr/>
          </p:nvCxnSpPr>
          <p:spPr>
            <a:xfrm flipH="1">
              <a:off x="3995280" y="2331720"/>
              <a:ext cx="132480" cy="12132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48" name="Straight Arrow Connector 9"/>
            <p:cNvCxnSpPr/>
            <p:nvPr/>
          </p:nvCxnSpPr>
          <p:spPr>
            <a:xfrm flipH="1">
              <a:off x="7626240" y="2322000"/>
              <a:ext cx="132480" cy="12132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49" name="Straight Arrow Connector 10"/>
            <p:cNvCxnSpPr/>
            <p:nvPr/>
          </p:nvCxnSpPr>
          <p:spPr>
            <a:xfrm flipH="1">
              <a:off x="7214400" y="5559480"/>
              <a:ext cx="130680" cy="12132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50" name="Straight Arrow Connector 11"/>
            <p:cNvCxnSpPr/>
            <p:nvPr/>
          </p:nvCxnSpPr>
          <p:spPr>
            <a:xfrm flipH="1">
              <a:off x="4115520" y="5553360"/>
              <a:ext cx="130680" cy="11952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51" name="Rectangle 12"/>
          <p:cNvSpPr/>
          <p:nvPr/>
        </p:nvSpPr>
        <p:spPr>
          <a:xfrm>
            <a:off x="754920" y="6383880"/>
            <a:ext cx="7908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igure S1. The distribution for the number of genes in a specific tissue. Arrow points to number of genes from abnormal regio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14"/>
          <p:cNvGrpSpPr/>
          <p:nvPr/>
        </p:nvGrpSpPr>
        <p:grpSpPr>
          <a:xfrm>
            <a:off x="1037160" y="1179360"/>
            <a:ext cx="7189920" cy="3780000"/>
            <a:chOff x="1037160" y="1179360"/>
            <a:chExt cx="7189920" cy="3780000"/>
          </a:xfrm>
        </p:grpSpPr>
        <p:grpSp>
          <p:nvGrpSpPr>
            <p:cNvPr id="53" name="Group 7"/>
            <p:cNvGrpSpPr/>
            <p:nvPr/>
          </p:nvGrpSpPr>
          <p:grpSpPr>
            <a:xfrm>
              <a:off x="1707840" y="1417320"/>
              <a:ext cx="5312160" cy="3542040"/>
              <a:chOff x="1707840" y="1417320"/>
              <a:chExt cx="5312160" cy="3542040"/>
            </a:xfrm>
          </p:grpSpPr>
          <p:pic>
            <p:nvPicPr>
              <p:cNvPr id="54" name="Diagram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707840" y="1417320"/>
                <a:ext cx="5312160" cy="35420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55" name="Group 6"/>
              <p:cNvGrpSpPr/>
              <p:nvPr/>
            </p:nvGrpSpPr>
            <p:grpSpPr>
              <a:xfrm>
                <a:off x="3240000" y="2178720"/>
                <a:ext cx="1565280" cy="1925280"/>
                <a:chOff x="3240000" y="2178720"/>
                <a:chExt cx="1565280" cy="1925280"/>
              </a:xfrm>
            </p:grpSpPr>
            <p:sp>
              <p:nvSpPr>
                <p:cNvPr id="56" name="TextBox 2"/>
                <p:cNvSpPr/>
                <p:nvPr/>
              </p:nvSpPr>
              <p:spPr>
                <a:xfrm>
                  <a:off x="3822840" y="2933640"/>
                  <a:ext cx="46404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7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TextBox 3"/>
                <p:cNvSpPr/>
                <p:nvPr/>
              </p:nvSpPr>
              <p:spPr>
                <a:xfrm>
                  <a:off x="3240000" y="2983680"/>
                  <a:ext cx="32256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4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TextBox 4"/>
                <p:cNvSpPr/>
                <p:nvPr/>
              </p:nvSpPr>
              <p:spPr>
                <a:xfrm>
                  <a:off x="4341240" y="2350800"/>
                  <a:ext cx="46404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58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TextBox 5"/>
                <p:cNvSpPr/>
                <p:nvPr/>
              </p:nvSpPr>
              <p:spPr>
                <a:xfrm>
                  <a:off x="3873960" y="3705120"/>
                  <a:ext cx="52884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2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TextBox 3"/>
                <p:cNvSpPr/>
                <p:nvPr/>
              </p:nvSpPr>
              <p:spPr>
                <a:xfrm>
                  <a:off x="3364920" y="3600000"/>
                  <a:ext cx="32256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TextBox 5"/>
                <p:cNvSpPr/>
                <p:nvPr/>
              </p:nvSpPr>
              <p:spPr>
                <a:xfrm>
                  <a:off x="3344400" y="2178720"/>
                  <a:ext cx="52884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9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62" name="TextBox 9"/>
            <p:cNvSpPr/>
            <p:nvPr/>
          </p:nvSpPr>
          <p:spPr>
            <a:xfrm>
              <a:off x="2058120" y="1179360"/>
              <a:ext cx="171396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31859c"/>
                  </a:solidFill>
                  <a:latin typeface="Arial"/>
                  <a:ea typeface="Arial"/>
                </a:rPr>
                <a:t>PubMed abstract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31859c"/>
                  </a:solidFill>
                  <a:latin typeface="Arial"/>
                  <a:ea typeface="Arial"/>
                </a:rPr>
                <a:t>(108 genes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11"/>
            <p:cNvSpPr/>
            <p:nvPr/>
          </p:nvSpPr>
          <p:spPr>
            <a:xfrm>
              <a:off x="6333480" y="4307040"/>
              <a:ext cx="18936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953735"/>
                  </a:solidFill>
                  <a:latin typeface="Arial"/>
                  <a:ea typeface="Arial"/>
                </a:rPr>
                <a:t>Expression pattern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953735"/>
                  </a:solidFill>
                  <a:latin typeface="Arial"/>
                  <a:ea typeface="Arial"/>
                </a:rPr>
                <a:t>(317 genes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10"/>
            <p:cNvSpPr/>
            <p:nvPr/>
          </p:nvSpPr>
          <p:spPr>
            <a:xfrm>
              <a:off x="1037160" y="3722760"/>
              <a:ext cx="196236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77933c"/>
                  </a:solidFill>
                  <a:latin typeface="Arial"/>
                  <a:ea typeface="Arial"/>
                </a:rPr>
                <a:t>Gene ontology term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77933c"/>
                  </a:solidFill>
                  <a:latin typeface="Arial"/>
                  <a:ea typeface="Arial"/>
                </a:rPr>
                <a:t>(45 genes)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" name="Rectangle 15"/>
          <p:cNvSpPr/>
          <p:nvPr/>
        </p:nvSpPr>
        <p:spPr>
          <a:xfrm>
            <a:off x="1257480" y="5582520"/>
            <a:ext cx="6991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2.  The number of candidate genes overlapping between the three data sourc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7" descr="C:\Cyto_Me (CM)\My Publications\My MSCs 12\MSC_12.2_MapMining\Msc_v8\BEGGOOff.png"/>
          <p:cNvPicPr/>
          <p:nvPr/>
        </p:nvPicPr>
        <p:blipFill>
          <a:blip r:embed="rId1"/>
          <a:stretch/>
        </p:blipFill>
        <p:spPr>
          <a:xfrm>
            <a:off x="1614600" y="228600"/>
            <a:ext cx="5919840" cy="5919840"/>
          </a:xfrm>
          <a:prstGeom prst="rect">
            <a:avLst/>
          </a:prstGeom>
          <a:ln w="0">
            <a:noFill/>
          </a:ln>
        </p:spPr>
      </p:pic>
      <p:sp>
        <p:nvSpPr>
          <p:cNvPr id="67" name="Rectangle 8"/>
          <p:cNvSpPr/>
          <p:nvPr/>
        </p:nvSpPr>
        <p:spPr>
          <a:xfrm>
            <a:off x="1081800" y="6220440"/>
            <a:ext cx="64566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3.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unctional connections between genes at the 73 critical regions inferred by GRAIL based 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Gene Ontology (significant genes with p&lt;0.0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1"/>
          <p:cNvSpPr/>
          <p:nvPr/>
        </p:nvSpPr>
        <p:spPr>
          <a:xfrm>
            <a:off x="1207080" y="6145920"/>
            <a:ext cx="62658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4.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unctional connections between genes at the 73 critical regions inferred by GRAIL base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Human Expression Alta (significant genes with p&lt;0.0000000001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2" descr="C:\Cyto_Me (CM)\My Publications\My MSCs 12\MSC_12.2_MapMining\Msc_v8\BEGExpOff.png"/>
          <p:cNvPicPr/>
          <p:nvPr/>
        </p:nvPicPr>
        <p:blipFill>
          <a:blip r:embed="rId1"/>
          <a:stretch/>
        </p:blipFill>
        <p:spPr>
          <a:xfrm>
            <a:off x="1285920" y="130320"/>
            <a:ext cx="5857920" cy="5857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2" descr=""/>
          <p:cNvPicPr/>
          <p:nvPr/>
        </p:nvPicPr>
        <p:blipFill>
          <a:blip r:embed="rId1"/>
          <a:stretch/>
        </p:blipFill>
        <p:spPr>
          <a:xfrm>
            <a:off x="1076400" y="409680"/>
            <a:ext cx="6902280" cy="5437080"/>
          </a:xfrm>
          <a:prstGeom prst="rect">
            <a:avLst/>
          </a:prstGeom>
          <a:ln w="0">
            <a:noFill/>
          </a:ln>
        </p:spPr>
      </p:pic>
      <p:sp>
        <p:nvSpPr>
          <p:cNvPr id="71" name="Rectangle 4"/>
          <p:cNvSpPr/>
          <p:nvPr/>
        </p:nvSpPr>
        <p:spPr>
          <a:xfrm>
            <a:off x="1172880" y="6058800"/>
            <a:ext cx="6134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5.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The secondary functional network of BEGs identified by the Ingenuity pathway analy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(genes denoted with red colored G-band position are in the candidate gene list of Table 1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2" descr=""/>
          <p:cNvPicPr/>
          <p:nvPr/>
        </p:nvPicPr>
        <p:blipFill>
          <a:blip r:embed="rId1"/>
          <a:stretch/>
        </p:blipFill>
        <p:spPr>
          <a:xfrm>
            <a:off x="1447920" y="549360"/>
            <a:ext cx="6237000" cy="5418000"/>
          </a:xfrm>
          <a:prstGeom prst="rect">
            <a:avLst/>
          </a:prstGeom>
          <a:ln w="0">
            <a:noFill/>
          </a:ln>
        </p:spPr>
      </p:pic>
      <p:sp>
        <p:nvSpPr>
          <p:cNvPr id="73" name="Rectangle 4"/>
          <p:cNvSpPr/>
          <p:nvPr/>
        </p:nvSpPr>
        <p:spPr>
          <a:xfrm>
            <a:off x="1170720" y="6058800"/>
            <a:ext cx="5749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6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The third functional network of BEGs identified by the Ingenuity pathway analy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(genes denoted with red colored G-band position are in the candidate gene list of Table 1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Picture 2" descr=""/>
          <p:cNvPicPr/>
          <p:nvPr/>
        </p:nvPicPr>
        <p:blipFill>
          <a:blip r:embed="rId1"/>
          <a:stretch/>
        </p:blipFill>
        <p:spPr>
          <a:xfrm>
            <a:off x="1533600" y="324000"/>
            <a:ext cx="6248160" cy="5661000"/>
          </a:xfrm>
          <a:prstGeom prst="rect">
            <a:avLst/>
          </a:prstGeom>
          <a:ln w="0">
            <a:noFill/>
          </a:ln>
        </p:spPr>
      </p:pic>
      <p:sp>
        <p:nvSpPr>
          <p:cNvPr id="75" name="Rectangle 4"/>
          <p:cNvSpPr/>
          <p:nvPr/>
        </p:nvSpPr>
        <p:spPr>
          <a:xfrm>
            <a:off x="1305000" y="6144480"/>
            <a:ext cx="58348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7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The fourth functional network of BEGs identified by the Ingenuity pathway analy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(genes denoted with red colored G-band position are in the candidate gene list of Table 1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2" descr=""/>
          <p:cNvPicPr/>
          <p:nvPr/>
        </p:nvPicPr>
        <p:blipFill>
          <a:blip r:embed="rId1"/>
          <a:stretch/>
        </p:blipFill>
        <p:spPr>
          <a:xfrm>
            <a:off x="1481040" y="133200"/>
            <a:ext cx="6162840" cy="5924880"/>
          </a:xfrm>
          <a:prstGeom prst="rect">
            <a:avLst/>
          </a:prstGeom>
          <a:ln w="0">
            <a:noFill/>
          </a:ln>
        </p:spPr>
      </p:pic>
      <p:sp>
        <p:nvSpPr>
          <p:cNvPr id="77" name="Rectangle 4"/>
          <p:cNvSpPr/>
          <p:nvPr/>
        </p:nvSpPr>
        <p:spPr>
          <a:xfrm>
            <a:off x="1404360" y="6144480"/>
            <a:ext cx="5743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8.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The fifth functional network of BEGs identified by the Ingenuity pathway analy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148608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(genes denoted with red colored G-band position are in the candidate gene list of Table 1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Fang Xu</dc:creator>
  <dc:description/>
  <dc:language>en-US</dc:language>
  <cp:lastModifiedBy>ITS</cp:lastModifiedBy>
  <cp:lastPrinted>2013-12-14T02:55:04Z</cp:lastPrinted>
  <dcterms:modified xsi:type="dcterms:W3CDTF">2013-12-14T22:38:34Z</dcterms:modified>
  <cp:revision>93</cp:revision>
  <dc:subject/>
  <dc:title>PowerPoint Presentation</dc:title>
</cp:coreProperties>
</file>